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506" r:id="rId2"/>
    <p:sldId id="501" r:id="rId3"/>
    <p:sldId id="502" r:id="rId4"/>
  </p:sldIdLst>
  <p:sldSz cx="12192000" cy="6858000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FF00FF"/>
    <a:srgbClr val="3333FF"/>
    <a:srgbClr val="000066"/>
    <a:srgbClr val="00CCFF"/>
    <a:srgbClr val="66FF33"/>
    <a:srgbClr val="990033"/>
    <a:srgbClr val="A50021"/>
    <a:srgbClr val="006600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08" autoAdjust="0"/>
    <p:restoredTop sz="96357" autoAdjust="0"/>
  </p:normalViewPr>
  <p:slideViewPr>
    <p:cSldViewPr snapToGrid="0">
      <p:cViewPr varScale="1">
        <p:scale>
          <a:sx n="110" d="100"/>
          <a:sy n="110" d="100"/>
        </p:scale>
        <p:origin x="732" y="138"/>
      </p:cViewPr>
      <p:guideLst/>
    </p:cSldViewPr>
  </p:slideViewPr>
  <p:outlineViewPr>
    <p:cViewPr>
      <p:scale>
        <a:sx n="33" d="100"/>
        <a:sy n="33" d="100"/>
      </p:scale>
      <p:origin x="0" y="-8376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50" d="100"/>
          <a:sy n="50" d="100"/>
        </p:scale>
        <p:origin x="2898" y="4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11" Type="http://schemas.microsoft.com/office/2016/11/relationships/changesInfo" Target="changesInfos/changesInfo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feng Peng" userId="977d67b5-6a2d-4389-a2d1-f7611f575af8" providerId="ADAL" clId="{DEA3E360-0EEF-4CBE-A6E7-92C33E573DAC}"/>
    <pc:docChg chg="delSld">
      <pc:chgData name="Lifeng Peng" userId="977d67b5-6a2d-4389-a2d1-f7611f575af8" providerId="ADAL" clId="{DEA3E360-0EEF-4CBE-A6E7-92C33E573DAC}" dt="2022-03-04T22:48:41.129" v="1" actId="47"/>
      <pc:docMkLst>
        <pc:docMk/>
      </pc:docMkLst>
      <pc:sldChg chg="del">
        <pc:chgData name="Lifeng Peng" userId="977d67b5-6a2d-4389-a2d1-f7611f575af8" providerId="ADAL" clId="{DEA3E360-0EEF-4CBE-A6E7-92C33E573DAC}" dt="2022-03-04T22:48:37.042" v="0" actId="47"/>
        <pc:sldMkLst>
          <pc:docMk/>
          <pc:sldMk cId="926368468" sldId="499"/>
        </pc:sldMkLst>
      </pc:sldChg>
      <pc:sldChg chg="del">
        <pc:chgData name="Lifeng Peng" userId="977d67b5-6a2d-4389-a2d1-f7611f575af8" providerId="ADAL" clId="{DEA3E360-0EEF-4CBE-A6E7-92C33E573DAC}" dt="2022-03-04T22:48:37.042" v="0" actId="47"/>
        <pc:sldMkLst>
          <pc:docMk/>
          <pc:sldMk cId="3086607569" sldId="500"/>
        </pc:sldMkLst>
      </pc:sldChg>
      <pc:sldChg chg="del">
        <pc:chgData name="Lifeng Peng" userId="977d67b5-6a2d-4389-a2d1-f7611f575af8" providerId="ADAL" clId="{DEA3E360-0EEF-4CBE-A6E7-92C33E573DAC}" dt="2022-03-04T22:48:41.129" v="1" actId="47"/>
        <pc:sldMkLst>
          <pc:docMk/>
          <pc:sldMk cId="565510306" sldId="503"/>
        </pc:sldMkLst>
      </pc:sldChg>
      <pc:sldChg chg="del">
        <pc:chgData name="Lifeng Peng" userId="977d67b5-6a2d-4389-a2d1-f7611f575af8" providerId="ADAL" clId="{DEA3E360-0EEF-4CBE-A6E7-92C33E573DAC}" dt="2022-03-04T22:48:41.129" v="1" actId="47"/>
        <pc:sldMkLst>
          <pc:docMk/>
          <pc:sldMk cId="3089828148" sldId="504"/>
        </pc:sldMkLst>
      </pc:sldChg>
      <pc:sldChg chg="del">
        <pc:chgData name="Lifeng Peng" userId="977d67b5-6a2d-4389-a2d1-f7611f575af8" providerId="ADAL" clId="{DEA3E360-0EEF-4CBE-A6E7-92C33E573DAC}" dt="2022-03-04T22:48:37.042" v="0" actId="47"/>
        <pc:sldMkLst>
          <pc:docMk/>
          <pc:sldMk cId="3557997074" sldId="505"/>
        </pc:sldMkLst>
      </pc:sldChg>
      <pc:sldChg chg="del">
        <pc:chgData name="Lifeng Peng" userId="977d67b5-6a2d-4389-a2d1-f7611f575af8" providerId="ADAL" clId="{DEA3E360-0EEF-4CBE-A6E7-92C33E573DAC}" dt="2022-03-04T22:48:41.129" v="1" actId="47"/>
        <pc:sldMkLst>
          <pc:docMk/>
          <pc:sldMk cId="709091179" sldId="507"/>
        </pc:sldMkLst>
      </pc:sldChg>
    </pc:docChg>
  </pc:docChgLst>
  <pc:docChgLst>
    <pc:chgData name="Lifeng Peng" userId="977d67b5-6a2d-4389-a2d1-f7611f575af8" providerId="ADAL" clId="{622236FC-3CF8-4297-9F71-A318A4D02FDA}"/>
    <pc:docChg chg="addSld modSld">
      <pc:chgData name="Lifeng Peng" userId="977d67b5-6a2d-4389-a2d1-f7611f575af8" providerId="ADAL" clId="{622236FC-3CF8-4297-9F71-A318A4D02FDA}" dt="2022-03-04T21:34:52.474" v="8" actId="6549"/>
      <pc:docMkLst>
        <pc:docMk/>
      </pc:docMkLst>
      <pc:sldChg chg="modSp mod">
        <pc:chgData name="Lifeng Peng" userId="977d67b5-6a2d-4389-a2d1-f7611f575af8" providerId="ADAL" clId="{622236FC-3CF8-4297-9F71-A318A4D02FDA}" dt="2022-03-04T21:34:00.415" v="2" actId="6549"/>
        <pc:sldMkLst>
          <pc:docMk/>
          <pc:sldMk cId="3557997074" sldId="505"/>
        </pc:sldMkLst>
        <pc:spChg chg="mod">
          <ac:chgData name="Lifeng Peng" userId="977d67b5-6a2d-4389-a2d1-f7611f575af8" providerId="ADAL" clId="{622236FC-3CF8-4297-9F71-A318A4D02FDA}" dt="2022-03-04T21:34:00.415" v="2" actId="6549"/>
          <ac:spMkLst>
            <pc:docMk/>
            <pc:sldMk cId="3557997074" sldId="505"/>
            <ac:spMk id="4" creationId="{B3006CA5-50B3-4F0F-AA3A-CA5C998E200A}"/>
          </ac:spMkLst>
        </pc:spChg>
      </pc:sldChg>
      <pc:sldChg chg="modSp add mod">
        <pc:chgData name="Lifeng Peng" userId="977d67b5-6a2d-4389-a2d1-f7611f575af8" providerId="ADAL" clId="{622236FC-3CF8-4297-9F71-A318A4D02FDA}" dt="2022-03-04T21:34:34.402" v="6" actId="6549"/>
        <pc:sldMkLst>
          <pc:docMk/>
          <pc:sldMk cId="3470445632" sldId="506"/>
        </pc:sldMkLst>
        <pc:spChg chg="mod">
          <ac:chgData name="Lifeng Peng" userId="977d67b5-6a2d-4389-a2d1-f7611f575af8" providerId="ADAL" clId="{622236FC-3CF8-4297-9F71-A318A4D02FDA}" dt="2022-03-04T21:34:34.402" v="6" actId="6549"/>
          <ac:spMkLst>
            <pc:docMk/>
            <pc:sldMk cId="3470445632" sldId="506"/>
            <ac:spMk id="4" creationId="{B3006CA5-50B3-4F0F-AA3A-CA5C998E200A}"/>
          </ac:spMkLst>
        </pc:spChg>
      </pc:sldChg>
      <pc:sldChg chg="modSp add mod">
        <pc:chgData name="Lifeng Peng" userId="977d67b5-6a2d-4389-a2d1-f7611f575af8" providerId="ADAL" clId="{622236FC-3CF8-4297-9F71-A318A4D02FDA}" dt="2022-03-04T21:34:52.474" v="8" actId="6549"/>
        <pc:sldMkLst>
          <pc:docMk/>
          <pc:sldMk cId="709091179" sldId="507"/>
        </pc:sldMkLst>
        <pc:spChg chg="mod">
          <ac:chgData name="Lifeng Peng" userId="977d67b5-6a2d-4389-a2d1-f7611f575af8" providerId="ADAL" clId="{622236FC-3CF8-4297-9F71-A318A4D02FDA}" dt="2022-03-04T21:34:52.474" v="8" actId="6549"/>
          <ac:spMkLst>
            <pc:docMk/>
            <pc:sldMk cId="709091179" sldId="507"/>
            <ac:spMk id="4" creationId="{B3006CA5-50B3-4F0F-AA3A-CA5C998E200A}"/>
          </ac:spMkLst>
        </pc:spChg>
      </pc:sldChg>
    </pc:docChg>
  </pc:docChgLst>
  <pc:docChgLst>
    <pc:chgData name="Lifeng Peng" userId="977d67b5-6a2d-4389-a2d1-f7611f575af8" providerId="ADAL" clId="{B4BF171F-E198-45A8-808D-2750A4473864}"/>
    <pc:docChg chg="custSel addSld modSld">
      <pc:chgData name="Lifeng Peng" userId="977d67b5-6a2d-4389-a2d1-f7611f575af8" providerId="ADAL" clId="{B4BF171F-E198-45A8-808D-2750A4473864}" dt="2021-10-09T17:47:23.690" v="6" actId="14100"/>
      <pc:docMkLst>
        <pc:docMk/>
      </pc:docMkLst>
      <pc:sldChg chg="addSp delSp modSp new mod">
        <pc:chgData name="Lifeng Peng" userId="977d67b5-6a2d-4389-a2d1-f7611f575af8" providerId="ADAL" clId="{B4BF171F-E198-45A8-808D-2750A4473864}" dt="2021-10-09T17:47:23.690" v="6" actId="14100"/>
        <pc:sldMkLst>
          <pc:docMk/>
          <pc:sldMk cId="3329700708" sldId="576"/>
        </pc:sldMkLst>
        <pc:spChg chg="del">
          <ac:chgData name="Lifeng Peng" userId="977d67b5-6a2d-4389-a2d1-f7611f575af8" providerId="ADAL" clId="{B4BF171F-E198-45A8-808D-2750A4473864}" dt="2021-10-09T17:47:13.654" v="1" actId="478"/>
          <ac:spMkLst>
            <pc:docMk/>
            <pc:sldMk cId="3329700708" sldId="576"/>
            <ac:spMk id="2" creationId="{F66698FE-6578-4945-9463-486792DCF1EF}"/>
          </ac:spMkLst>
        </pc:spChg>
        <pc:picChg chg="add mod">
          <ac:chgData name="Lifeng Peng" userId="977d67b5-6a2d-4389-a2d1-f7611f575af8" providerId="ADAL" clId="{B4BF171F-E198-45A8-808D-2750A4473864}" dt="2021-10-09T17:47:23.690" v="6" actId="14100"/>
          <ac:picMkLst>
            <pc:docMk/>
            <pc:sldMk cId="3329700708" sldId="576"/>
            <ac:picMk id="4" creationId="{D0FDC36C-F9A6-4E23-96C3-E4297A424422}"/>
          </ac:picMkLst>
        </pc:picChg>
      </pc:sldChg>
    </pc:docChg>
  </pc:docChgLst>
  <pc:docChgLst>
    <pc:chgData name="Lifeng Peng" userId="977d67b5-6a2d-4389-a2d1-f7611f575af8" providerId="ADAL" clId="{432D4320-2DD1-492B-A932-86F2C1762B69}"/>
    <pc:docChg chg="modSld">
      <pc:chgData name="Lifeng Peng" userId="977d67b5-6a2d-4389-a2d1-f7611f575af8" providerId="ADAL" clId="{432D4320-2DD1-492B-A932-86F2C1762B69}" dt="2022-06-06T22:22:03.401" v="9" actId="14100"/>
      <pc:docMkLst>
        <pc:docMk/>
      </pc:docMkLst>
      <pc:sldChg chg="modSp mod">
        <pc:chgData name="Lifeng Peng" userId="977d67b5-6a2d-4389-a2d1-f7611f575af8" providerId="ADAL" clId="{432D4320-2DD1-492B-A932-86F2C1762B69}" dt="2022-06-06T22:21:54.161" v="5" actId="14100"/>
        <pc:sldMkLst>
          <pc:docMk/>
          <pc:sldMk cId="4281938686" sldId="501"/>
        </pc:sldMkLst>
        <pc:spChg chg="mod">
          <ac:chgData name="Lifeng Peng" userId="977d67b5-6a2d-4389-a2d1-f7611f575af8" providerId="ADAL" clId="{432D4320-2DD1-492B-A932-86F2C1762B69}" dt="2022-06-06T22:21:54.161" v="5" actId="14100"/>
          <ac:spMkLst>
            <pc:docMk/>
            <pc:sldMk cId="4281938686" sldId="501"/>
            <ac:spMk id="7" creationId="{91A046DF-BFBC-4115-93DA-69C9A0474087}"/>
          </ac:spMkLst>
        </pc:spChg>
      </pc:sldChg>
      <pc:sldChg chg="modSp mod">
        <pc:chgData name="Lifeng Peng" userId="977d67b5-6a2d-4389-a2d1-f7611f575af8" providerId="ADAL" clId="{432D4320-2DD1-492B-A932-86F2C1762B69}" dt="2022-06-06T22:22:03.401" v="9" actId="14100"/>
        <pc:sldMkLst>
          <pc:docMk/>
          <pc:sldMk cId="2958194408" sldId="502"/>
        </pc:sldMkLst>
        <pc:spChg chg="mod">
          <ac:chgData name="Lifeng Peng" userId="977d67b5-6a2d-4389-a2d1-f7611f575af8" providerId="ADAL" clId="{432D4320-2DD1-492B-A932-86F2C1762B69}" dt="2022-06-06T22:22:03.401" v="9" actId="14100"/>
          <ac:spMkLst>
            <pc:docMk/>
            <pc:sldMk cId="2958194408" sldId="502"/>
            <ac:spMk id="4" creationId="{86F3EF7A-E79A-4E39-8DB0-7198EC183B96}"/>
          </ac:spMkLst>
        </pc:spChg>
      </pc:sldChg>
      <pc:sldChg chg="modSp mod">
        <pc:chgData name="Lifeng Peng" userId="977d67b5-6a2d-4389-a2d1-f7611f575af8" providerId="ADAL" clId="{432D4320-2DD1-492B-A932-86F2C1762B69}" dt="2022-06-06T22:21:42.117" v="1" actId="20577"/>
        <pc:sldMkLst>
          <pc:docMk/>
          <pc:sldMk cId="3470445632" sldId="506"/>
        </pc:sldMkLst>
        <pc:spChg chg="mod">
          <ac:chgData name="Lifeng Peng" userId="977d67b5-6a2d-4389-a2d1-f7611f575af8" providerId="ADAL" clId="{432D4320-2DD1-492B-A932-86F2C1762B69}" dt="2022-06-06T22:21:42.117" v="1" actId="20577"/>
          <ac:spMkLst>
            <pc:docMk/>
            <pc:sldMk cId="3470445632" sldId="506"/>
            <ac:spMk id="4" creationId="{B3006CA5-50B3-4F0F-AA3A-CA5C998E200A}"/>
          </ac:spMkLst>
        </pc:spChg>
      </pc:sldChg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NZ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B189384C-AFAE-415D-BAFB-C047AD5846B6}" type="datetimeFigureOut">
              <a:rPr lang="en-NZ" smtClean="0"/>
              <a:t>7/06/2022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867174E1-5D42-4826-87CB-0C3147E56240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1785647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42" y="2"/>
            <a:ext cx="2949787" cy="498694"/>
          </a:xfrm>
          <a:prstGeom prst="rect">
            <a:avLst/>
          </a:prstGeom>
        </p:spPr>
        <p:txBody>
          <a:bodyPr vert="horz" lIns="91421" tIns="45710" rIns="91421" bIns="45710" rtlCol="0"/>
          <a:lstStyle>
            <a:lvl1pPr algn="r">
              <a:defRPr sz="1200"/>
            </a:lvl1pPr>
          </a:lstStyle>
          <a:p>
            <a:fld id="{392ABA83-70EF-4BEB-98AD-CB1BA412F4CD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3863" y="1243013"/>
            <a:ext cx="5959475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1" tIns="45710" rIns="91421" bIns="4571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9"/>
            <a:ext cx="5445760" cy="3913615"/>
          </a:xfrm>
          <a:prstGeom prst="rect">
            <a:avLst/>
          </a:prstGeom>
        </p:spPr>
        <p:txBody>
          <a:bodyPr vert="horz" lIns="91421" tIns="45710" rIns="91421" bIns="4571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42" y="9440649"/>
            <a:ext cx="2949787" cy="498691"/>
          </a:xfrm>
          <a:prstGeom prst="rect">
            <a:avLst/>
          </a:prstGeom>
        </p:spPr>
        <p:txBody>
          <a:bodyPr vert="horz" lIns="91421" tIns="45710" rIns="91421" bIns="45710" rtlCol="0" anchor="b"/>
          <a:lstStyle>
            <a:lvl1pPr algn="r">
              <a:defRPr sz="1200"/>
            </a:lvl1pPr>
          </a:lstStyle>
          <a:p>
            <a:fld id="{7E24DD7F-04EE-4BC3-84CB-E1B412AB7AC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05347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01689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47546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1779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7449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081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741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85500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79663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569834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92826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72659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1A8AE-3C37-4A06-BCE6-5C0455A28749}" type="datetimeFigureOut">
              <a:rPr lang="en-AU" smtClean="0"/>
              <a:t>7/06/202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81CF8-AA61-4841-907E-20499159B86B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36920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B3006CA5-50B3-4F0F-AA3A-CA5C998E200A}"/>
              </a:ext>
            </a:extLst>
          </p:cNvPr>
          <p:cNvSpPr/>
          <p:nvPr/>
        </p:nvSpPr>
        <p:spPr>
          <a:xfrm>
            <a:off x="470262" y="358567"/>
            <a:ext cx="11190515" cy="347043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NZ" sz="1600" b="1" dirty="0"/>
              <a:t>Additional File 10: Analysis of proteins with significantly differential expression in HGCA tissues compared to LGCA tissues. A, </a:t>
            </a:r>
            <a:r>
              <a:rPr lang="en-NZ" sz="1600" dirty="0"/>
              <a:t>Proteins with significantly increased abundance with a medium confidence level (0.4), with GO terms or KEGG or </a:t>
            </a:r>
            <a:r>
              <a:rPr lang="en-NZ" sz="1600" dirty="0" err="1"/>
              <a:t>Reactome</a:t>
            </a:r>
            <a:r>
              <a:rPr lang="en-NZ" sz="1600" dirty="0"/>
              <a:t> pathways of interest coloured as follows: Red – detoxification; Blue – cellular zinc ion homeostasis; Light Green – regulation of growth; Yellow – immune response; Pink – immune system process; Teal – neutrophil degranulation; Orange – positive regulation of cell growth; Purple – leukocyte mediated immunity; Brown – myeloid leukocyte activation. </a:t>
            </a:r>
            <a:r>
              <a:rPr lang="en-NZ" sz="1600" b="1" dirty="0"/>
              <a:t>B, </a:t>
            </a:r>
            <a:r>
              <a:rPr lang="en-NZ" sz="1600" dirty="0"/>
              <a:t>Proteins with significantly decreased abundance with a medium confidence level (0.4), with GO terms or KEGG or </a:t>
            </a:r>
            <a:r>
              <a:rPr lang="en-NZ" sz="1600" dirty="0" err="1"/>
              <a:t>Reactome</a:t>
            </a:r>
            <a:r>
              <a:rPr lang="en-NZ" sz="1600" dirty="0"/>
              <a:t> pathways of interest coloured as follows: Red – nitrogen metabolism; Blue – tyrosine metabolism; Yellow – drug metabolism cytochrome P450.</a:t>
            </a:r>
          </a:p>
        </p:txBody>
      </p:sp>
    </p:spTree>
    <p:extLst>
      <p:ext uri="{BB962C8B-B14F-4D97-AF65-F5344CB8AC3E}">
        <p14:creationId xmlns:p14="http://schemas.microsoft.com/office/powerpoint/2010/main" val="34704456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91A046DF-BFBC-4115-93DA-69C9A0474087}"/>
              </a:ext>
            </a:extLst>
          </p:cNvPr>
          <p:cNvSpPr txBox="1"/>
          <p:nvPr/>
        </p:nvSpPr>
        <p:spPr>
          <a:xfrm>
            <a:off x="407405" y="126749"/>
            <a:ext cx="20222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File 10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79E3AB8-652D-4488-AD33-3AFE56B137A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9829" y="0"/>
            <a:ext cx="905234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19386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6F3EF7A-E79A-4E39-8DB0-7198EC183B96}"/>
              </a:ext>
            </a:extLst>
          </p:cNvPr>
          <p:cNvSpPr txBox="1"/>
          <p:nvPr/>
        </p:nvSpPr>
        <p:spPr>
          <a:xfrm>
            <a:off x="407406" y="126749"/>
            <a:ext cx="2439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dirty="0"/>
              <a:t>Additional File 10B</a:t>
            </a:r>
          </a:p>
        </p:txBody>
      </p:sp>
      <p:pic>
        <p:nvPicPr>
          <p:cNvPr id="3" name="Picture 2" descr="A picture containing background pattern&#10;&#10;Description automatically generated">
            <a:extLst>
              <a:ext uri="{FF2B5EF4-FFF2-40B4-BE49-F238E27FC236}">
                <a16:creationId xmlns:a16="http://schemas.microsoft.com/office/drawing/2014/main" id="{8364232B-191B-4C44-9838-181BCE1F8B4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6926" y="0"/>
            <a:ext cx="64981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8194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80</TotalTime>
  <Words>15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feng Peng</dc:creator>
  <cp:lastModifiedBy>Lifeng Peng</cp:lastModifiedBy>
  <cp:revision>1150</cp:revision>
  <cp:lastPrinted>2019-05-17T00:46:07Z</cp:lastPrinted>
  <dcterms:created xsi:type="dcterms:W3CDTF">2014-04-18T17:12:37Z</dcterms:created>
  <dcterms:modified xsi:type="dcterms:W3CDTF">2022-06-06T22:22:04Z</dcterms:modified>
</cp:coreProperties>
</file>